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C6C23-BE2B-4F98-95F5-029B171B42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37F23-0BA5-4901-A315-FB181D7F38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B698E-3A8E-40DB-ACD7-4CCB7D406C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10263-C355-4CDC-BACA-93D800C6FD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7FB20-6A93-4F42-BE2C-0BB56DAB8B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EB2D4-9A8B-4B96-8985-CFBB639EE2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15EE3-A31D-4CB3-9560-E9BE63A798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4A904-B3B0-4B07-89C4-1F08D3C39C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A279D-604C-46C1-B1B7-A1D106840A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7199B-0D7E-41C2-8835-1F0645FB73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CC3270-2ABA-408A-A34B-8E4FF4D3AE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7657D-2F4C-4C85-B877-C20CCDC372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D6A378-255E-42A0-9EE2-D044D23DA476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矩形 4"/>
          <p:cNvSpPr/>
          <p:nvPr/>
        </p:nvSpPr>
        <p:spPr>
          <a:xfrm>
            <a:off x="512640" y="642960"/>
            <a:ext cx="169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3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8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2571840" y="2357280"/>
          <a:ext cx="3857400" cy="1463760"/>
        </p:xfrm>
        <a:graphic>
          <a:graphicData uri="http://schemas.openxmlformats.org/drawingml/2006/table">
            <a:tbl>
              <a:tblPr/>
              <a:tblGrid>
                <a:gridCol w="1784160"/>
                <a:gridCol w="1036800"/>
                <a:gridCol w="1036440"/>
              </a:tblGrid>
              <a:tr h="36540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SS (bp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e end 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*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bp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4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ximal polyA si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DejaVu Sans"/>
                        </a:rPr>
                        <a:t>60281.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DejaVu Sans"/>
                        </a:rPr>
                        <a:t>32200.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540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-betwe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DejaVu Sans"/>
                        </a:rPr>
                        <a:t>85590.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DejaVu Sans"/>
                        </a:rPr>
                        <a:t>11150.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64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stal polyA si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DejaVu Sans"/>
                        </a:rPr>
                        <a:t>89651.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2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DejaVu Sans"/>
                        </a:rPr>
                        <a:t>3732.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TextBox 6"/>
          <p:cNvSpPr/>
          <p:nvPr/>
        </p:nvSpPr>
        <p:spPr>
          <a:xfrm>
            <a:off x="2571840" y="3857760"/>
            <a:ext cx="4429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 The coordinates of the TSS and the end of the genes were obtained from the annotation of RefSeq genes in UCSC Table Browser (hg18 database, http://genome.ucsc.edu/cgi-bin/hgTables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6T01:38:50Z</dcterms:created>
  <dc:creator>huanghuan</dc:creator>
  <dc:description/>
  <dc:language>en-US</dc:language>
  <cp:lastModifiedBy>huanghuan</cp:lastModifiedBy>
  <dcterms:modified xsi:type="dcterms:W3CDTF">2013-11-20T06:46:50Z</dcterms:modified>
  <cp:revision>54</cp:revision>
  <dc:subject/>
  <dc:title>幻灯片 1</dc:title>
</cp:coreProperties>
</file>